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4" autoAdjust="0"/>
    <p:restoredTop sz="94660"/>
  </p:normalViewPr>
  <p:slideViewPr>
    <p:cSldViewPr snapToGrid="0">
      <p:cViewPr varScale="1">
        <p:scale>
          <a:sx n="68" d="100"/>
          <a:sy n="68" d="100"/>
        </p:scale>
        <p:origin x="616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6281169-1CE3-4688-B1D6-D11E9A330CD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F5996065-150D-4744-86E3-5E5AD9BDFFE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E12A2186-40A5-4570-877B-CAD1AFFF35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D3E4BA-8C72-4433-8249-600E0BB5AB63}" type="datetimeFigureOut">
              <a:rPr lang="fr-FR" smtClean="0"/>
              <a:t>19/05/2018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29F64A5-77A0-42AD-B54A-DF35B8D134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F7E473F-1877-41C5-A894-4B910D0F60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E2641-E8B9-46E0-B8B3-206AA1ECA85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045953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2CC0B7C-7702-48C1-963D-97F187FEBF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6367E39E-6250-41CD-A6CB-5570BF58F7F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EDD6AEF8-40A6-4738-8FAB-71ACAD5AA0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D3E4BA-8C72-4433-8249-600E0BB5AB63}" type="datetimeFigureOut">
              <a:rPr lang="fr-FR" smtClean="0"/>
              <a:t>19/05/2018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38C97E6-5837-4A41-8A09-30AB1FD5B4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CED1B29-FFAE-4893-9D14-2BE8760F23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E2641-E8B9-46E0-B8B3-206AA1ECA85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003061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E0512A4C-B0DD-4E22-913C-E86B5CF5FBF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CDBF3F03-9E61-43A3-983C-12FA5D2278D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8F6153F3-682E-4785-A8A2-860C318581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D3E4BA-8C72-4433-8249-600E0BB5AB63}" type="datetimeFigureOut">
              <a:rPr lang="fr-FR" smtClean="0"/>
              <a:t>19/05/2018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EEB73571-F15B-46EA-95CF-F0B789D05B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26BCD4D-9183-4552-B0D2-B6D0C33CDD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E2641-E8B9-46E0-B8B3-206AA1ECA85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971819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622D1A8-A35C-482F-8F53-D0732C4235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AF210699-C09A-4BFD-96F8-B7906E250B8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9663C1F3-FD6C-4E5F-AD3F-B09AAFF3AA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D3E4BA-8C72-4433-8249-600E0BB5AB63}" type="datetimeFigureOut">
              <a:rPr lang="fr-FR" smtClean="0"/>
              <a:t>19/05/2018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AA450EA-6171-4E5E-B867-85286443F2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684FAFFF-EE34-4CDD-BF20-8094B87B1F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E2641-E8B9-46E0-B8B3-206AA1ECA85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187263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BC3C558-573B-4E3C-BF87-0D27A0C82D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9898E2E6-86EF-41E6-9264-2B0FB4B5B2D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80B79C6C-EDBB-4C22-93B6-6419FD4ED5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D3E4BA-8C72-4433-8249-600E0BB5AB63}" type="datetimeFigureOut">
              <a:rPr lang="fr-FR" smtClean="0"/>
              <a:t>19/05/2018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980E2F0-6301-413E-9A12-ED8579BDE0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02BA3C3-08B2-4EA6-A7BF-BB9CC14247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E2641-E8B9-46E0-B8B3-206AA1ECA85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472403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EDDBD35-A835-4B59-ADF3-B0819CB2BB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B2F7DB44-043E-48A5-8263-2B2FAEEF5FC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A68BD3F6-5E57-4AB4-817D-36A13581147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FF3CE0A8-19D2-456E-8425-B99CE59618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D3E4BA-8C72-4433-8249-600E0BB5AB63}" type="datetimeFigureOut">
              <a:rPr lang="fr-FR" smtClean="0"/>
              <a:t>19/05/2018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D77ACB2A-7A1C-439C-AB2D-DBA5ABBCB1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1222A678-AA66-47A8-8D8A-90C2425F6E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E2641-E8B9-46E0-B8B3-206AA1ECA85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583446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6027A4B-46A4-4176-9D10-37CBCBC382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38321F97-1F4D-4C1F-8790-2C5FB21F224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ED2E4582-2370-414C-8967-05A2252BA85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819E3B17-0F04-4433-8108-D012B6BE899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BFA9DB9D-CA8B-4F9E-AFEA-206D3686ECA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3278E655-6867-4603-8568-7FAB820F17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D3E4BA-8C72-4433-8249-600E0BB5AB63}" type="datetimeFigureOut">
              <a:rPr lang="fr-FR" smtClean="0"/>
              <a:t>19/05/2018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BB47B9AA-0FA0-4B3A-9C7D-D043F95CD4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E63D6236-A130-4133-A007-628C043CCB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E2641-E8B9-46E0-B8B3-206AA1ECA85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114734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6769A43-08B7-4C21-A6BF-8D14FEB60B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FBFF1BE1-5F57-48BB-95C1-D85C328C53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D3E4BA-8C72-4433-8249-600E0BB5AB63}" type="datetimeFigureOut">
              <a:rPr lang="fr-FR" smtClean="0"/>
              <a:t>19/05/2018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B984037A-5F02-49EB-8F10-B4EA8FD943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FF04D51A-5225-4E7A-B061-4560B313C2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E2641-E8B9-46E0-B8B3-206AA1ECA85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902670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C6447273-4145-413D-A764-DAC574514F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D3E4BA-8C72-4433-8249-600E0BB5AB63}" type="datetimeFigureOut">
              <a:rPr lang="fr-FR" smtClean="0"/>
              <a:t>19/05/2018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9E9EB098-C63C-4CFE-8B5E-59445B1B7C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2098F284-AD2E-44B6-BE96-3BB3AAA14F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E2641-E8B9-46E0-B8B3-206AA1ECA85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041077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05548EE-752F-467B-8463-6D3AC5F0A0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AC1E2CDC-6EF6-4B31-A35F-6D7BFB2DD20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82D595D7-7E59-4980-A5F2-0B53D0FC532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166CCFCE-4B67-4974-A010-8A34B65547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D3E4BA-8C72-4433-8249-600E0BB5AB63}" type="datetimeFigureOut">
              <a:rPr lang="fr-FR" smtClean="0"/>
              <a:t>19/05/2018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3E7C8C55-4885-4615-B2AE-342B8F50D0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780CDD2F-6B2D-4B00-870B-FD6EE5E512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E2641-E8B9-46E0-B8B3-206AA1ECA85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008868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0FDD43E-532B-4D15-B8B2-950E29747F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F28D1A86-B083-4FED-944A-A38D7057B21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B3CBF548-0BF6-4A10-8138-EC91211D829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624C9782-1BE4-4F5F-8347-1BCCB41628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D3E4BA-8C72-4433-8249-600E0BB5AB63}" type="datetimeFigureOut">
              <a:rPr lang="fr-FR" smtClean="0"/>
              <a:t>19/05/2018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6298E783-55D1-4FAF-B46D-13C461676D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903E7FE4-151B-4322-80FC-9785CA30B4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E2641-E8B9-46E0-B8B3-206AA1ECA85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415069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12E1037F-62A3-44E1-A45F-95CB82BDB5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802F53FF-AE45-4369-8379-1F2E1A4BB8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E4B79AE3-383C-47F9-84BB-AF15BEBB845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D3E4BA-8C72-4433-8249-600E0BB5AB63}" type="datetimeFigureOut">
              <a:rPr lang="fr-FR" smtClean="0"/>
              <a:t>19/05/2018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BABB94C-3B13-4BB4-B3E1-FFE32FFEEC8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6F2BD6F5-A835-4B9E-86A7-BF8CEE344DB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7E2641-E8B9-46E0-B8B3-206AA1ECA85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804260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Flèche : bas 3">
            <a:extLst>
              <a:ext uri="{FF2B5EF4-FFF2-40B4-BE49-F238E27FC236}">
                <a16:creationId xmlns:a16="http://schemas.microsoft.com/office/drawing/2014/main" id="{9D9F6BC9-59A6-4444-86AE-723B817625D1}"/>
              </a:ext>
            </a:extLst>
          </p:cNvPr>
          <p:cNvSpPr/>
          <p:nvPr/>
        </p:nvSpPr>
        <p:spPr>
          <a:xfrm>
            <a:off x="5573485" y="711203"/>
            <a:ext cx="1261513" cy="5747654"/>
          </a:xfrm>
          <a:prstGeom prst="downArrow">
            <a:avLst/>
          </a:prstGeom>
          <a:solidFill>
            <a:schemeClr val="accent3">
              <a:lumMod val="20000"/>
              <a:lumOff val="80000"/>
            </a:schemeClr>
          </a:solidFill>
          <a:ln w="28575">
            <a:solidFill>
              <a:schemeClr val="tx1"/>
            </a:solidFill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C2AA8506-4DFC-41E0-9991-6DAD98B03E44}"/>
              </a:ext>
            </a:extLst>
          </p:cNvPr>
          <p:cNvSpPr/>
          <p:nvPr/>
        </p:nvSpPr>
        <p:spPr>
          <a:xfrm>
            <a:off x="5718627" y="1593519"/>
            <a:ext cx="971227" cy="31931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b="1" dirty="0">
                <a:solidFill>
                  <a:schemeClr val="tx1"/>
                </a:solidFill>
              </a:rPr>
              <a:t>27/10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B265B45C-91BB-4F3B-9302-0B8AF115AE72}"/>
              </a:ext>
            </a:extLst>
          </p:cNvPr>
          <p:cNvSpPr/>
          <p:nvPr/>
        </p:nvSpPr>
        <p:spPr>
          <a:xfrm>
            <a:off x="5718627" y="4665546"/>
            <a:ext cx="971227" cy="19594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b="1" dirty="0">
                <a:solidFill>
                  <a:schemeClr val="tx1"/>
                </a:solidFill>
              </a:rPr>
              <a:t>17/11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7B937882-FDB0-4512-8FBE-2A7BA8AB6456}"/>
              </a:ext>
            </a:extLst>
          </p:cNvPr>
          <p:cNvSpPr/>
          <p:nvPr/>
        </p:nvSpPr>
        <p:spPr>
          <a:xfrm>
            <a:off x="5718627" y="5334495"/>
            <a:ext cx="971227" cy="19594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b="1" dirty="0">
                <a:solidFill>
                  <a:schemeClr val="tx1"/>
                </a:solidFill>
              </a:rPr>
              <a:t>24/11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5B7ADE11-882E-47B1-9F66-BDB6DC05C431}"/>
              </a:ext>
            </a:extLst>
          </p:cNvPr>
          <p:cNvSpPr/>
          <p:nvPr/>
        </p:nvSpPr>
        <p:spPr>
          <a:xfrm>
            <a:off x="4752810" y="61810"/>
            <a:ext cx="2931886" cy="649392"/>
          </a:xfrm>
          <a:prstGeom prst="rect">
            <a:avLst/>
          </a:prstGeom>
          <a:solidFill>
            <a:schemeClr val="accent3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</a:rPr>
              <a:t>Pain and mobility of maxillary right central incisor</a:t>
            </a:r>
            <a:endParaRPr lang="fr-FR" b="1" dirty="0">
              <a:solidFill>
                <a:schemeClr val="tx1"/>
              </a:solidFill>
            </a:endParaRP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30AD9F63-B705-4D60-B2F1-A0504A914ADC}"/>
              </a:ext>
            </a:extLst>
          </p:cNvPr>
          <p:cNvSpPr/>
          <p:nvPr/>
        </p:nvSpPr>
        <p:spPr>
          <a:xfrm>
            <a:off x="4752810" y="5986468"/>
            <a:ext cx="2931886" cy="738688"/>
          </a:xfrm>
          <a:prstGeom prst="rect">
            <a:avLst/>
          </a:prstGeom>
          <a:solidFill>
            <a:schemeClr val="accent3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b="1" dirty="0"/>
              <a:t>Resolution of this episode of care</a:t>
            </a:r>
            <a:endParaRPr lang="fr-FR" b="1" dirty="0">
              <a:solidFill>
                <a:schemeClr val="tx1"/>
              </a:solidFill>
            </a:endParaRP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7B2A09D1-701A-450D-AD19-51FE07F88F9E}"/>
              </a:ext>
            </a:extLst>
          </p:cNvPr>
          <p:cNvSpPr/>
          <p:nvPr/>
        </p:nvSpPr>
        <p:spPr>
          <a:xfrm>
            <a:off x="2638425" y="1300799"/>
            <a:ext cx="3017594" cy="1135247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</a:rPr>
              <a:t>Physical examination, diagnostic evaluation, digital impression, dental radiograph and written consent</a:t>
            </a:r>
            <a:endParaRPr lang="fr-FR" b="1" dirty="0">
              <a:solidFill>
                <a:schemeClr val="tx1"/>
              </a:solidFill>
            </a:endParaRP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46DC161D-0A00-4A13-8667-6E65A59D4456}"/>
              </a:ext>
            </a:extLst>
          </p:cNvPr>
          <p:cNvSpPr/>
          <p:nvPr/>
        </p:nvSpPr>
        <p:spPr>
          <a:xfrm>
            <a:off x="5089959" y="2549974"/>
            <a:ext cx="2257587" cy="608040"/>
          </a:xfrm>
          <a:prstGeom prst="rect">
            <a:avLst/>
          </a:prstGeom>
          <a:solidFill>
            <a:schemeClr val="accent3">
              <a:lumMod val="40000"/>
              <a:lumOff val="60000"/>
            </a:schemeClr>
          </a:solidFill>
          <a:ln w="28575">
            <a:solidFill>
              <a:schemeClr val="tx1"/>
            </a:solidFill>
          </a:ln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</a:rPr>
              <a:t>Patient final decision</a:t>
            </a:r>
          </a:p>
          <a:p>
            <a:pPr algn="ctr"/>
            <a:r>
              <a:rPr lang="en-US" b="1" dirty="0">
                <a:solidFill>
                  <a:schemeClr val="tx1"/>
                </a:solidFill>
              </a:rPr>
              <a:t>3/11</a:t>
            </a:r>
            <a:endParaRPr lang="fr-FR" b="1" dirty="0">
              <a:solidFill>
                <a:schemeClr val="tx1"/>
              </a:solidFill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34C5D8B5-723C-4A8A-83B6-298E7DC83079}"/>
              </a:ext>
            </a:extLst>
          </p:cNvPr>
          <p:cNvSpPr/>
          <p:nvPr/>
        </p:nvSpPr>
        <p:spPr>
          <a:xfrm>
            <a:off x="2638425" y="4512909"/>
            <a:ext cx="3000376" cy="608040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b="1" dirty="0"/>
              <a:t>Tooth extraction and denture try-in</a:t>
            </a:r>
            <a:endParaRPr lang="fr-FR" dirty="0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52640F25-7BB7-4531-8218-0E2CA2F84B87}"/>
              </a:ext>
            </a:extLst>
          </p:cNvPr>
          <p:cNvSpPr/>
          <p:nvPr/>
        </p:nvSpPr>
        <p:spPr>
          <a:xfrm>
            <a:off x="2638425" y="808271"/>
            <a:ext cx="3014889" cy="348168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5">
              <a:shade val="50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</a:rPr>
              <a:t>Clinical steps</a:t>
            </a:r>
            <a:endParaRPr lang="fr-FR" b="1" dirty="0">
              <a:solidFill>
                <a:schemeClr val="tx1"/>
              </a:solidFill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6729F2B4-9159-481D-96F5-6A439359B0BB}"/>
              </a:ext>
            </a:extLst>
          </p:cNvPr>
          <p:cNvSpPr/>
          <p:nvPr/>
        </p:nvSpPr>
        <p:spPr>
          <a:xfrm>
            <a:off x="6752464" y="3254668"/>
            <a:ext cx="2931886" cy="1158950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b="1" dirty="0"/>
              <a:t>Tooth virtual removal, conception and manufacturing of the removable partial denture</a:t>
            </a:r>
            <a:endParaRPr lang="fr-FR" dirty="0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00048C58-98EC-42F7-AACE-EF0290EBADAB}"/>
              </a:ext>
            </a:extLst>
          </p:cNvPr>
          <p:cNvSpPr/>
          <p:nvPr/>
        </p:nvSpPr>
        <p:spPr>
          <a:xfrm>
            <a:off x="6752466" y="796624"/>
            <a:ext cx="2931886" cy="359814"/>
          </a:xfrm>
          <a:prstGeom prst="rect">
            <a:avLst/>
          </a:prstGeom>
          <a:solidFill>
            <a:schemeClr val="accent2">
              <a:lumMod val="40000"/>
              <a:lumOff val="60000"/>
            </a:schemeClr>
          </a:solidFill>
          <a:ln w="19050">
            <a:solidFill>
              <a:schemeClr val="tx1"/>
            </a:solidFill>
          </a:ln>
        </p:spPr>
        <p:style>
          <a:lnRef idx="2">
            <a:schemeClr val="accent5">
              <a:shade val="50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</a:rPr>
              <a:t>Technical steps</a:t>
            </a:r>
            <a:endParaRPr lang="fr-FR" b="1" dirty="0">
              <a:solidFill>
                <a:schemeClr val="tx1"/>
              </a:solidFill>
            </a:endParaRP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02B4CDEC-BD81-4397-BC7F-FE5C9E9A703A}"/>
              </a:ext>
            </a:extLst>
          </p:cNvPr>
          <p:cNvSpPr/>
          <p:nvPr/>
        </p:nvSpPr>
        <p:spPr>
          <a:xfrm>
            <a:off x="2638424" y="5242097"/>
            <a:ext cx="3000376" cy="401992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b="1" dirty="0"/>
              <a:t>One week recall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98583284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7</TotalTime>
  <Words>59</Words>
  <Application>Microsoft Office PowerPoint</Application>
  <PresentationFormat>Grand écran</PresentationFormat>
  <Paragraphs>1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xime Ducret</dc:creator>
  <cp:lastModifiedBy>Maxime</cp:lastModifiedBy>
  <cp:revision>7</cp:revision>
  <dcterms:created xsi:type="dcterms:W3CDTF">2018-01-28T14:12:34Z</dcterms:created>
  <dcterms:modified xsi:type="dcterms:W3CDTF">2018-05-19T09:01:51Z</dcterms:modified>
</cp:coreProperties>
</file>